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embeddings/oleObject4.xlsx" ContentType="application/vnd.openxmlformats-officedocument.spreadsheetml.shee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F0F58D-AE94-48A4-8355-941F49058AB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06B73C-3FD2-4590-A456-2860849008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818BA9-596A-4727-A8E6-6EA667C72B7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369041-549F-42A3-B226-06725E4F4FA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2858BC-5809-415F-8607-17FCD37748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81CAF8-F8E8-4C5E-A510-BDA0F4817F7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687F11-72EA-4E38-829F-A2C04FD6E1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3A0996-D473-4A16-BA98-D3DF33062E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B23760-6ABD-49E3-8111-F8BA0A5367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755410-B2F5-4398-8B5A-2D3F427DFF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63396D-6BF2-4423-8033-DDF1FBD975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3A3F65-1625-4C0C-A569-4EE0D17207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he-IL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he-IL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427A47F-42CD-4149-9DC7-D3524C1621EF}" type="slidenum">
              <a:rPr b="0" lang="he-I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package" Target="../embeddings/oleObject3.xlsx"/><Relationship Id="rId6" Type="http://schemas.openxmlformats.org/officeDocument/2006/relationships/image" Target="../media/image3.wmf"/><Relationship Id="rId7" Type="http://schemas.openxmlformats.org/officeDocument/2006/relationships/package" Target="../embeddings/oleObject4.xlsx"/><Relationship Id="rId8" Type="http://schemas.openxmlformats.org/officeDocument/2006/relationships/image" Target="../media/image4.wmf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071080" y="304920"/>
            <a:ext cx="686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emal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304920" y="457200"/>
          <a:ext cx="4219560" cy="21621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04920" y="457200"/>
                    <a:ext cx="4219560" cy="2162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4" name=""/>
          <p:cNvSpPr/>
          <p:nvPr/>
        </p:nvSpPr>
        <p:spPr>
          <a:xfrm>
            <a:off x="153720" y="2588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609480" y="5548320"/>
            <a:ext cx="762012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igure S1. Genetic interactions between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Dlmo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pnr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or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fng.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&amp;B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pnr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</a:rPr>
              <a:t>V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does not interact genetically with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Dlmo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</a:rPr>
              <a:t>Bx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in the wing.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A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 Genotype of the test group (in gray) is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Dlmo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Bx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/+;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pnr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V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/+ and the control group (in black) is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Dlmo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Bx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/+.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B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 Genotype of the test group (in gray) is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Dlmo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Bx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/Y;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pnr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V1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/+ and the control group (in black) is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Dlmo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Bx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/Y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&amp;D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fng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</a:rPr>
              <a:t>80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enhances the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Dlmo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</a:rPr>
              <a:t>Bx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wing phenotype.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C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 Genotype of the test group (in gray) is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Dlmo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Bx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/+;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fng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</a:rPr>
              <a:t>80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/+ and the control group (in black) is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Dlmo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Bx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/+.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B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 Genotype of the test group (in gray) is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Dlmo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Bx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/Y;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fng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</a:rPr>
              <a:t>80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/+ and the control group (in black) is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Dlmo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Bx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/Y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6" name=""/>
          <p:cNvGraphicFramePr/>
          <p:nvPr/>
        </p:nvGraphicFramePr>
        <p:xfrm>
          <a:off x="4772160" y="457200"/>
          <a:ext cx="4219560" cy="216216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7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772160" y="457200"/>
                    <a:ext cx="4219560" cy="2162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8" name=""/>
          <p:cNvSpPr/>
          <p:nvPr/>
        </p:nvSpPr>
        <p:spPr>
          <a:xfrm>
            <a:off x="6615360" y="30492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Mal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649760" y="2588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0" name=""/>
          <p:cNvGraphicFramePr/>
          <p:nvPr/>
        </p:nvGraphicFramePr>
        <p:xfrm>
          <a:off x="304920" y="3095640"/>
          <a:ext cx="4219560" cy="2162160"/>
        </p:xfrm>
        <a:graphic>
          <a:graphicData uri="http://schemas.openxmlformats.org/presentationml/2006/ole">
            <p:oleObj progId="Excel.Sheet.12" r:id="rId5" spid="">
              <p:embed/>
              <p:pic>
                <p:nvPicPr>
                  <p:cNvPr id="51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304920" y="3095640"/>
                    <a:ext cx="4219560" cy="2162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2" name=""/>
          <p:cNvSpPr/>
          <p:nvPr/>
        </p:nvSpPr>
        <p:spPr>
          <a:xfrm>
            <a:off x="2071080" y="3019320"/>
            <a:ext cx="686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emal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53720" y="29433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4" name=""/>
          <p:cNvGraphicFramePr/>
          <p:nvPr/>
        </p:nvGraphicFramePr>
        <p:xfrm>
          <a:off x="4772160" y="3095640"/>
          <a:ext cx="4219560" cy="2162160"/>
        </p:xfrm>
        <a:graphic>
          <a:graphicData uri="http://schemas.openxmlformats.org/presentationml/2006/ole">
            <p:oleObj progId="Excel.Sheet.12" r:id="rId7" spid="">
              <p:embed/>
              <p:pic>
                <p:nvPicPr>
                  <p:cNvPr id="55" name="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4772160" y="3095640"/>
                    <a:ext cx="4219560" cy="2162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6" name=""/>
          <p:cNvSpPr/>
          <p:nvPr/>
        </p:nvSpPr>
        <p:spPr>
          <a:xfrm>
            <a:off x="4649760" y="29433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6615360" y="301932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Mal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702440" y="2514600"/>
            <a:ext cx="1456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henotype severity clas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702440" y="5105520"/>
            <a:ext cx="1456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henotype severity clas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6169680" y="2438280"/>
            <a:ext cx="1456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henotype severity clas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6169680" y="5105520"/>
            <a:ext cx="1456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henotype severity clas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rot="16200000">
            <a:off x="-18000" y="1422360"/>
            <a:ext cx="724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requenc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rot="16200000">
            <a:off x="4401360" y="1422360"/>
            <a:ext cx="724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requenc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rot="16200000">
            <a:off x="-18000" y="4060800"/>
            <a:ext cx="724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requenc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rot="16200000">
            <a:off x="4401360" y="4060800"/>
            <a:ext cx="724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requenc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14T13:41:38Z</dcterms:created>
  <dc:creator>Revital Bronstien</dc:creator>
  <dc:description/>
  <dc:language>en-US</dc:language>
  <cp:lastModifiedBy>Revital Bronstien</cp:lastModifiedBy>
  <dcterms:modified xsi:type="dcterms:W3CDTF">2010-06-28T12:20:27Z</dcterms:modified>
  <cp:revision>8</cp:revision>
  <dc:subject/>
  <dc:title>שקופית 1</dc:title>
</cp:coreProperties>
</file>